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AF62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726" y="17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1978" y="3551188"/>
            <a:ext cx="2581575" cy="12345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1978" y="5281669"/>
            <a:ext cx="2587062" cy="12345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0250" y="5281668"/>
            <a:ext cx="2587062" cy="12345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0250" y="3531983"/>
            <a:ext cx="2587062" cy="12729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1 CuadroTexto"/>
          <p:cNvSpPr txBox="1"/>
          <p:nvPr/>
        </p:nvSpPr>
        <p:spPr>
          <a:xfrm>
            <a:off x="1888113" y="3351044"/>
            <a:ext cx="7713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tyledon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8 CuadroTexto"/>
          <p:cNvSpPr txBox="1"/>
          <p:nvPr/>
        </p:nvSpPr>
        <p:spPr>
          <a:xfrm>
            <a:off x="4796902" y="3347864"/>
            <a:ext cx="4427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af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9 CuadroTexto"/>
          <p:cNvSpPr txBox="1"/>
          <p:nvPr/>
        </p:nvSpPr>
        <p:spPr>
          <a:xfrm>
            <a:off x="2040513" y="5092067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ot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10 CuadroTexto"/>
          <p:cNvSpPr txBox="1"/>
          <p:nvPr/>
        </p:nvSpPr>
        <p:spPr>
          <a:xfrm>
            <a:off x="4716439" y="5083559"/>
            <a:ext cx="6142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loem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3 CuadroTexto"/>
          <p:cNvSpPr txBox="1"/>
          <p:nvPr/>
        </p:nvSpPr>
        <p:spPr>
          <a:xfrm>
            <a:off x="853063" y="2854841"/>
            <a:ext cx="15135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lementa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11 CuadroTexto"/>
          <p:cNvSpPr txBox="1"/>
          <p:nvPr/>
        </p:nvSpPr>
        <p:spPr>
          <a:xfrm>
            <a:off x="1923960" y="4733671"/>
            <a:ext cx="57099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NA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ze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12 CuadroTexto"/>
          <p:cNvSpPr txBox="1"/>
          <p:nvPr/>
        </p:nvSpPr>
        <p:spPr>
          <a:xfrm>
            <a:off x="4686168" y="4731918"/>
            <a:ext cx="57099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NA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ze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13 CuadroTexto"/>
          <p:cNvSpPr txBox="1"/>
          <p:nvPr/>
        </p:nvSpPr>
        <p:spPr>
          <a:xfrm>
            <a:off x="1920294" y="6452739"/>
            <a:ext cx="57099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NA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ze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14 CuadroTexto"/>
          <p:cNvSpPr txBox="1"/>
          <p:nvPr/>
        </p:nvSpPr>
        <p:spPr>
          <a:xfrm>
            <a:off x="4682502" y="6450986"/>
            <a:ext cx="57099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NA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ze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16 CuadroTexto"/>
          <p:cNvSpPr txBox="1"/>
          <p:nvPr/>
        </p:nvSpPr>
        <p:spPr>
          <a:xfrm rot="16200000">
            <a:off x="274408" y="4026675"/>
            <a:ext cx="101021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endogenous -</a:t>
            </a:r>
            <a:r>
              <a:rPr lang="en-US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NA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17 CuadroTexto"/>
          <p:cNvSpPr txBox="1"/>
          <p:nvPr/>
        </p:nvSpPr>
        <p:spPr>
          <a:xfrm rot="16200000">
            <a:off x="274472" y="5741161"/>
            <a:ext cx="101021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endogenous -</a:t>
            </a:r>
            <a:r>
              <a:rPr lang="en-US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NA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18 CuadroTexto"/>
          <p:cNvSpPr txBox="1"/>
          <p:nvPr/>
        </p:nvSpPr>
        <p:spPr>
          <a:xfrm rot="16200000">
            <a:off x="3066437" y="4054728"/>
            <a:ext cx="101021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endogenous -</a:t>
            </a:r>
            <a:r>
              <a:rPr lang="en-US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NA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19 CuadroTexto"/>
          <p:cNvSpPr txBox="1"/>
          <p:nvPr/>
        </p:nvSpPr>
        <p:spPr>
          <a:xfrm rot="16200000">
            <a:off x="3066500" y="5741161"/>
            <a:ext cx="101021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endogenous -</a:t>
            </a:r>
            <a:r>
              <a:rPr lang="en-US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NA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832830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40</TotalTime>
  <Words>31</Words>
  <Application>Microsoft Office PowerPoint</Application>
  <PresentationFormat>Presentación en pantalla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Carmen</dc:creator>
  <cp:lastModifiedBy>MariCarmen</cp:lastModifiedBy>
  <cp:revision>13</cp:revision>
  <dcterms:created xsi:type="dcterms:W3CDTF">2014-03-03T17:11:30Z</dcterms:created>
  <dcterms:modified xsi:type="dcterms:W3CDTF">2014-10-20T15:06:07Z</dcterms:modified>
</cp:coreProperties>
</file>